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4" r:id="rId2"/>
    <p:sldId id="266" r:id="rId3"/>
    <p:sldId id="454" r:id="rId4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wano fumika" initials="kf" lastIdx="1" clrIdx="0">
    <p:extLst>
      <p:ext uri="{19B8F6BF-5375-455C-9EA6-DF929625EA0E}">
        <p15:presenceInfo xmlns:p15="http://schemas.microsoft.com/office/powerpoint/2012/main" userId="a061f065d4b9417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907" autoAdjust="0"/>
    <p:restoredTop sz="95958" autoAdjust="0"/>
  </p:normalViewPr>
  <p:slideViewPr>
    <p:cSldViewPr snapToGrid="0">
      <p:cViewPr varScale="1">
        <p:scale>
          <a:sx n="89" d="100"/>
          <a:sy n="89" d="100"/>
        </p:scale>
        <p:origin x="492" y="8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2E7499-01FC-4136-9666-64133ECCADB7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C2B407-8CF2-4F1E-8693-934EF6A7E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1360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男子　</a:t>
            </a:r>
            <a:r>
              <a:rPr kumimoji="1" lang="en-US" altLang="ja-JP" dirty="0"/>
              <a:t>joinpoint0</a:t>
            </a:r>
            <a:r>
              <a:rPr kumimoji="1" lang="ja-JP" altLang="en-US" dirty="0"/>
              <a:t>点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C2B407-8CF2-4F1E-8693-934EF6A7E99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3247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女子　</a:t>
            </a:r>
            <a:r>
              <a:rPr kumimoji="1" lang="en-US" altLang="ja-JP" dirty="0"/>
              <a:t>joinpoint0</a:t>
            </a:r>
            <a:r>
              <a:rPr kumimoji="1" lang="ja-JP" altLang="en-US" dirty="0"/>
              <a:t>点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C2B407-8CF2-4F1E-8693-934EF6A7E99F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44068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FC840F-3DCA-46E5-8A82-AF1A6C75806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80656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447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800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816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382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31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15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7096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7492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7664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3122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450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E7B709-3A79-45E4-8B6E-9A9ADAB5A56F}" type="datetimeFigureOut">
              <a:rPr kumimoji="1" lang="ja-JP" altLang="en-US" smtClean="0"/>
              <a:t>2023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1AD09-D733-41C5-A67B-51E294408A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755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C195297-8A5A-4B16-F51A-D9B1038224B2}"/>
              </a:ext>
            </a:extLst>
          </p:cNvPr>
          <p:cNvSpPr txBox="1"/>
          <p:nvPr/>
        </p:nvSpPr>
        <p:spPr>
          <a:xfrm>
            <a:off x="105925" y="223749"/>
            <a:ext cx="90380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(A) </a:t>
            </a:r>
          </a:p>
          <a:p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nnual trend of age-standardized incidence rate of T1D for boys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719D6593-8061-5922-9C4C-FE00F3D9FE5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56" t="7577" r="27099" b="7325"/>
          <a:stretch/>
        </p:blipFill>
        <p:spPr>
          <a:xfrm>
            <a:off x="1790598" y="895644"/>
            <a:ext cx="5883275" cy="5015962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A8EFB46-C227-B51E-A7F2-5A30C7AAF9E8}"/>
              </a:ext>
            </a:extLst>
          </p:cNvPr>
          <p:cNvSpPr txBox="1"/>
          <p:nvPr/>
        </p:nvSpPr>
        <p:spPr>
          <a:xfrm rot="16200000">
            <a:off x="-437463" y="2951005"/>
            <a:ext cx="45431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entury" panose="02040604050505020304" pitchFamily="18" charset="0"/>
                <a:ea typeface="メイリオ" panose="020B0604030504040204" pitchFamily="50" charset="-128"/>
              </a:rPr>
              <a:t>Age-</a:t>
            </a:r>
            <a:r>
              <a:rPr kumimoji="1" lang="en-US" altLang="ja-JP" sz="1600" dirty="0" err="1">
                <a:latin typeface="Century" panose="02040604050505020304" pitchFamily="18" charset="0"/>
                <a:ea typeface="メイリオ" panose="020B0604030504040204" pitchFamily="50" charset="-128"/>
              </a:rPr>
              <a:t>stanaarized</a:t>
            </a:r>
            <a:r>
              <a:rPr kumimoji="1" lang="en-US" altLang="ja-JP" sz="1600" dirty="0">
                <a:latin typeface="Century" panose="02040604050505020304" pitchFamily="18" charset="0"/>
                <a:ea typeface="メイリオ" panose="020B0604030504040204" pitchFamily="50" charset="-128"/>
              </a:rPr>
              <a:t> incidence rate / 100,000year</a:t>
            </a:r>
            <a:endParaRPr kumimoji="1" lang="ja-JP" altLang="en-US" sz="1600" dirty="0">
              <a:latin typeface="Century" panose="02040604050505020304" pitchFamily="18" charset="0"/>
              <a:ea typeface="メイリオ" panose="020B0604030504040204" pitchFamily="50" charset="-128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9BE9176-7FFD-F37D-56E6-B4F55C91EBC0}"/>
              </a:ext>
            </a:extLst>
          </p:cNvPr>
          <p:cNvSpPr txBox="1"/>
          <p:nvPr/>
        </p:nvSpPr>
        <p:spPr>
          <a:xfrm>
            <a:off x="839096" y="5902397"/>
            <a:ext cx="779929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data was analyzed every two years because annual values cannot be calculated due to an error if there is a point of 0%. 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annual percent change (APC)= 6.6 (P=0.018; 95% CI, [1.3, 11.4]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3292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68A696A-5BD9-2A29-97FE-D19B612262CC}"/>
              </a:ext>
            </a:extLst>
          </p:cNvPr>
          <p:cNvSpPr txBox="1"/>
          <p:nvPr/>
        </p:nvSpPr>
        <p:spPr>
          <a:xfrm>
            <a:off x="105925" y="280033"/>
            <a:ext cx="90380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(B) </a:t>
            </a:r>
          </a:p>
          <a:p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nnual trend of age-standardized incidence rate of T1D for girl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39AD19AF-FAFA-4017-DDA8-D127626A80F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48" t="7480" r="26081" b="9001"/>
          <a:stretch/>
        </p:blipFill>
        <p:spPr>
          <a:xfrm>
            <a:off x="1762625" y="1179070"/>
            <a:ext cx="5712515" cy="4714875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97AC5D4-AC6B-B456-FD0C-86B9108114CF}"/>
              </a:ext>
            </a:extLst>
          </p:cNvPr>
          <p:cNvSpPr txBox="1"/>
          <p:nvPr/>
        </p:nvSpPr>
        <p:spPr>
          <a:xfrm rot="16200000">
            <a:off x="-427839" y="3081231"/>
            <a:ext cx="45431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entury" panose="02040604050505020304" pitchFamily="18" charset="0"/>
                <a:ea typeface="メイリオ" panose="020B0604030504040204" pitchFamily="50" charset="-128"/>
              </a:rPr>
              <a:t>Age-</a:t>
            </a:r>
            <a:r>
              <a:rPr kumimoji="1" lang="en-US" altLang="ja-JP" sz="1600" dirty="0" err="1">
                <a:latin typeface="Century" panose="02040604050505020304" pitchFamily="18" charset="0"/>
                <a:ea typeface="メイリオ" panose="020B0604030504040204" pitchFamily="50" charset="-128"/>
              </a:rPr>
              <a:t>stanaarized</a:t>
            </a:r>
            <a:r>
              <a:rPr kumimoji="1" lang="en-US" altLang="ja-JP" sz="1600" dirty="0">
                <a:latin typeface="Century" panose="02040604050505020304" pitchFamily="18" charset="0"/>
                <a:ea typeface="メイリオ" panose="020B0604030504040204" pitchFamily="50" charset="-128"/>
              </a:rPr>
              <a:t> incidence rate / 100,000year</a:t>
            </a:r>
            <a:endParaRPr kumimoji="1" lang="ja-JP" altLang="en-US" sz="1600" dirty="0">
              <a:latin typeface="Century" panose="02040604050505020304" pitchFamily="18" charset="0"/>
              <a:ea typeface="メイリオ" panose="020B0604030504040204" pitchFamily="50" charset="-128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DAF60BF-8F28-9205-16F2-3FC404DEE7A6}"/>
              </a:ext>
            </a:extLst>
          </p:cNvPr>
          <p:cNvSpPr txBox="1"/>
          <p:nvPr/>
        </p:nvSpPr>
        <p:spPr>
          <a:xfrm>
            <a:off x="903643" y="5959736"/>
            <a:ext cx="781005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ata was analyzed every two years because annual values cannot be calculated due to an error if there is a point of 0%.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APC= 4.8 (P=0. 187; 95% CI, [-2.7, 12.9]). </a:t>
            </a:r>
          </a:p>
        </p:txBody>
      </p:sp>
    </p:spTree>
    <p:extLst>
      <p:ext uri="{BB962C8B-B14F-4D97-AF65-F5344CB8AC3E}">
        <p14:creationId xmlns:p14="http://schemas.microsoft.com/office/powerpoint/2010/main" val="29318770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7AE26D2A-FC00-0406-B837-05F8123964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5420655"/>
              </p:ext>
            </p:extLst>
          </p:nvPr>
        </p:nvGraphicFramePr>
        <p:xfrm>
          <a:off x="1159726" y="1506101"/>
          <a:ext cx="7046428" cy="42145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6030">
                  <a:extLst>
                    <a:ext uri="{9D8B030D-6E8A-4147-A177-3AD203B41FA5}">
                      <a16:colId xmlns:a16="http://schemas.microsoft.com/office/drawing/2014/main" val="668468640"/>
                    </a:ext>
                  </a:extLst>
                </a:gridCol>
                <a:gridCol w="1340800">
                  <a:extLst>
                    <a:ext uri="{9D8B030D-6E8A-4147-A177-3AD203B41FA5}">
                      <a16:colId xmlns:a16="http://schemas.microsoft.com/office/drawing/2014/main" val="2510359337"/>
                    </a:ext>
                  </a:extLst>
                </a:gridCol>
                <a:gridCol w="1814025">
                  <a:extLst>
                    <a:ext uri="{9D8B030D-6E8A-4147-A177-3AD203B41FA5}">
                      <a16:colId xmlns:a16="http://schemas.microsoft.com/office/drawing/2014/main" val="3091261989"/>
                    </a:ext>
                  </a:extLst>
                </a:gridCol>
                <a:gridCol w="1566742">
                  <a:extLst>
                    <a:ext uri="{9D8B030D-6E8A-4147-A177-3AD203B41FA5}">
                      <a16:colId xmlns:a16="http://schemas.microsoft.com/office/drawing/2014/main" val="671273682"/>
                    </a:ext>
                  </a:extLst>
                </a:gridCol>
                <a:gridCol w="1488831">
                  <a:extLst>
                    <a:ext uri="{9D8B030D-6E8A-4147-A177-3AD203B41FA5}">
                      <a16:colId xmlns:a16="http://schemas.microsoft.com/office/drawing/2014/main" val="3112921515"/>
                    </a:ext>
                  </a:extLst>
                </a:gridCol>
              </a:tblGrid>
              <a:tr h="325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bgroup</a:t>
                      </a: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ual increase(%)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3979350"/>
                  </a:ext>
                </a:extLst>
              </a:tr>
              <a:tr h="325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iod</a:t>
                      </a:r>
                      <a:endParaRPr lang="en-US" sz="16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1999326"/>
                  </a:ext>
                </a:extLst>
              </a:tr>
              <a:tr h="3288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9-2002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-55.6, 184.9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4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7023751"/>
                  </a:ext>
                </a:extLst>
              </a:tr>
              <a:tr h="3288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3-2006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-41.9, 72.8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98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5122341"/>
                  </a:ext>
                </a:extLst>
              </a:tr>
              <a:tr h="3288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7-2010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-10.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-62.8, 113.5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2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9621065"/>
                  </a:ext>
                </a:extLst>
              </a:tr>
              <a:tr h="3288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1-2014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-19.0, 117.5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3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1474422"/>
                  </a:ext>
                </a:extLst>
              </a:tr>
              <a:tr h="3288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-2018</a:t>
                      </a:r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-13.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-74.5, 197.2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7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8127315"/>
                  </a:ext>
                </a:extLst>
              </a:tr>
              <a:tr h="32885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9-2018</a:t>
                      </a:r>
                      <a:r>
                        <a:rPr lang="en-US" altLang="ja-JP" sz="16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lang="en-US" sz="16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1.1, 9.8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16*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5167679"/>
                  </a:ext>
                </a:extLst>
              </a:tr>
              <a:tr h="409691"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9-2021</a:t>
                      </a:r>
                      <a:r>
                        <a:rPr lang="en-US" altLang="ja-JP" sz="16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‡</a:t>
                      </a:r>
                      <a:endParaRPr lang="en-US" altLang="ja-JP" sz="16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1.7, 7.8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04*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4147462"/>
                  </a:ext>
                </a:extLst>
              </a:tr>
              <a:tr h="1181224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r>
                        <a:rPr lang="en-US" altLang="ja-JP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valuated time period (1999-2018)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‡ </a:t>
                      </a:r>
                      <a:r>
                        <a:rPr lang="en-US" altLang="ja-JP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all time period including 2019-2021</a:t>
                      </a: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746" marR="6746" marT="67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43582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E91FB5E-CCF6-3B3E-4A82-D30E31C90506}"/>
              </a:ext>
            </a:extLst>
          </p:cNvPr>
          <p:cNvSpPr txBox="1"/>
          <p:nvPr/>
        </p:nvSpPr>
        <p:spPr>
          <a:xfrm>
            <a:off x="479531" y="322634"/>
            <a:ext cx="806439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upplementary TABLE. </a:t>
            </a:r>
          </a:p>
          <a:p>
            <a:r>
              <a:rPr lang="en-US" altLang="ja-JP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nnual increases in incidence rate over a 20-year period as estimated by mixed effects Poisson regression in subgroups defined by 4-year time period.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24D7AF1-4637-E55A-125F-255BD434ECC6}"/>
              </a:ext>
            </a:extLst>
          </p:cNvPr>
          <p:cNvSpPr txBox="1"/>
          <p:nvPr/>
        </p:nvSpPr>
        <p:spPr>
          <a:xfrm>
            <a:off x="1125246" y="5385575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ctr"/>
            <a:r>
              <a:rPr kumimoji="1" lang="en-US" altLang="ja-JP" sz="1800" kern="1200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* P &lt;0.05</a:t>
            </a:r>
            <a:endParaRPr lang="ja-JP" altLang="en-US" sz="1600" b="0" i="0" u="none" strike="noStrike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7909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50</TotalTime>
  <Words>277</Words>
  <Application>Microsoft Office PowerPoint</Application>
  <PresentationFormat>画面に合わせる (4:3)</PresentationFormat>
  <Paragraphs>63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游ゴシック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no fumika</dc:creator>
  <cp:lastModifiedBy>k-ihara@oita-u.ac.jp</cp:lastModifiedBy>
  <cp:revision>168</cp:revision>
  <cp:lastPrinted>2021-12-20T06:15:05Z</cp:lastPrinted>
  <dcterms:created xsi:type="dcterms:W3CDTF">2021-12-20T06:11:34Z</dcterms:created>
  <dcterms:modified xsi:type="dcterms:W3CDTF">2023-03-22T12:29:53Z</dcterms:modified>
</cp:coreProperties>
</file>